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5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843"/>
    <p:restoredTop sz="94648"/>
  </p:normalViewPr>
  <p:slideViewPr>
    <p:cSldViewPr snapToGrid="0">
      <p:cViewPr varScale="1">
        <p:scale>
          <a:sx n="53" d="100"/>
          <a:sy n="53" d="100"/>
        </p:scale>
        <p:origin x="2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Google Shape;581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2" name="Google Shape;58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446729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30942DF-2355-98EC-7988-2560089A93E4}"/>
              </a:ext>
            </a:extLst>
          </p:cNvPr>
          <p:cNvGraphicFramePr>
            <a:graphicFrameLocks noGrp="1"/>
          </p:cNvGraphicFramePr>
          <p:nvPr/>
        </p:nvGraphicFramePr>
        <p:xfrm>
          <a:off x="1249378" y="2372706"/>
          <a:ext cx="6328609" cy="251297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29149">
                  <a:extLst>
                    <a:ext uri="{9D8B030D-6E8A-4147-A177-3AD203B41FA5}">
                      <a16:colId xmlns:a16="http://schemas.microsoft.com/office/drawing/2014/main" val="4508968"/>
                    </a:ext>
                  </a:extLst>
                </a:gridCol>
                <a:gridCol w="2695844">
                  <a:extLst>
                    <a:ext uri="{9D8B030D-6E8A-4147-A177-3AD203B41FA5}">
                      <a16:colId xmlns:a16="http://schemas.microsoft.com/office/drawing/2014/main" val="3617749739"/>
                    </a:ext>
                  </a:extLst>
                </a:gridCol>
                <a:gridCol w="2603616">
                  <a:extLst>
                    <a:ext uri="{9D8B030D-6E8A-4147-A177-3AD203B41FA5}">
                      <a16:colId xmlns:a16="http://schemas.microsoft.com/office/drawing/2014/main" val="3757258441"/>
                    </a:ext>
                  </a:extLst>
                </a:gridCol>
              </a:tblGrid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en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Forward primer sequ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Reverse primer sequ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79317772"/>
                  </a:ext>
                </a:extLst>
              </a:tr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CL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CTCCAATCTTGCAGTCG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ACCGAGTGGGAGTAGGG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269577186"/>
                  </a:ext>
                </a:extLst>
              </a:tr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CR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AGGTGAGACATCCGTTCC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TTGGCAGGGTGCTGACATA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758521243"/>
                  </a:ext>
                </a:extLst>
              </a:tr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CL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GCTGGAGAGCTACAAGAGG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GTCAGCACAGACCTCTCT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811191589"/>
                  </a:ext>
                </a:extLst>
              </a:tr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XCL1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TCCGCTGCAACTGCATCCAT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AGGATAGGCTCGCAGGGA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037410295"/>
                  </a:ext>
                </a:extLst>
              </a:tr>
              <a:tr h="3142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APDH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CCCAGAAGACTGTGGATGG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CACATTGGGGGTAGGAAC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016917114"/>
                  </a:ext>
                </a:extLst>
              </a:tr>
              <a:tr h="31363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TGF-â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GGACTCTCCACCTGCAAGA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CTGGCGAGCCTTAGTTTGG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468268183"/>
                  </a:ext>
                </a:extLst>
              </a:tr>
              <a:tr h="31363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IFN-ã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>
                          <a:effectLst/>
                        </a:rPr>
                        <a:t>AGCAAGGCGAAAAAGGATG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CA" sz="1100" dirty="0">
                          <a:effectLst/>
                        </a:rPr>
                        <a:t>TCATTGAATGCTTGGCGCTG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19876287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489CB1D-A55E-5584-FA56-5B3EBCEAC960}"/>
              </a:ext>
            </a:extLst>
          </p:cNvPr>
          <p:cNvSpPr txBox="1"/>
          <p:nvPr/>
        </p:nvSpPr>
        <p:spPr>
          <a:xfrm>
            <a:off x="1249378" y="1499427"/>
            <a:ext cx="6089885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CA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3. qPCR primer sequences. </a:t>
            </a:r>
            <a:endParaRPr lang="en-CA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3928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36</Words>
  <Application>Microsoft Macintosh PowerPoint</Application>
  <PresentationFormat>Custom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2</cp:revision>
  <dcterms:created xsi:type="dcterms:W3CDTF">2024-06-04T23:51:01Z</dcterms:created>
  <dcterms:modified xsi:type="dcterms:W3CDTF">2024-06-05T01:38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